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media/image5.wmf" ContentType="image/x-wmf"/>
  <Override PartName="/ppt/media/image7.jpeg" ContentType="image/jpeg"/>
  <Override PartName="/ppt/media/image6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4A79C2-41B2-477F-839F-21ED444D5E4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582912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967000"/>
            <a:ext cx="582912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52EAC6-5371-45F6-9B81-67A692058D7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96700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96700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53AB82-02F9-4ACF-96FC-8300408BCA2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86236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86236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96700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96700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96700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EF2601-BC1A-48D8-B3B7-224BEBCC4D1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862360"/>
            <a:ext cx="5829120" cy="5943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37FC82-CBF0-4FDC-BBE1-646DA596643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582912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C032CE-AD94-484A-B3BB-08580514DD8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AB7F28-6E47-4C40-BA02-3D1A93B67BE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F3EF88-5D6F-4FDF-8F06-488CA482297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80560"/>
            <a:ext cx="582912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E5954E-3EB1-43F0-A405-7C20B881268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96700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8BEE5C-DE84-46CC-AE31-EE3A4082374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96700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F03275-1E91-47E8-BF30-C3281DC5110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967000"/>
            <a:ext cx="582912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6516E8-6B96-43DC-A230-43B95A552D2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862360"/>
            <a:ext cx="582912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9024480"/>
            <a:ext cx="1428840" cy="66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4480"/>
            <a:ext cx="2171520" cy="66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9024480"/>
            <a:ext cx="1428480" cy="66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CF52224-3F55-4CF6-8093-569F0A1C7102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wmf"/><Relationship Id="rId4" Type="http://schemas.openxmlformats.org/officeDocument/2006/relationships/image" Target="../media/image4.wmf"/><Relationship Id="rId5" Type="http://schemas.openxmlformats.org/officeDocument/2006/relationships/image" Target="../media/image5.wmf"/><Relationship Id="rId6" Type="http://schemas.openxmlformats.org/officeDocument/2006/relationships/image" Target="../media/image6.wmf"/><Relationship Id="rId7" Type="http://schemas.openxmlformats.org/officeDocument/2006/relationships/image" Target="../media/image7.jpeg"/><Relationship Id="rId8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1266840" y="3917880"/>
            <a:ext cx="1482840" cy="480960"/>
          </a:xfrm>
          <a:prstGeom prst="rect">
            <a:avLst/>
          </a:prstGeom>
          <a:ln w="0">
            <a:noFill/>
          </a:ln>
        </p:spPr>
      </p:pic>
      <p:pic>
        <p:nvPicPr>
          <p:cNvPr id="42" name="" descr=""/>
          <p:cNvPicPr/>
          <p:nvPr/>
        </p:nvPicPr>
        <p:blipFill>
          <a:blip r:embed="rId2"/>
          <a:stretch/>
        </p:blipFill>
        <p:spPr>
          <a:xfrm>
            <a:off x="3324240" y="3983040"/>
            <a:ext cx="1324080" cy="380880"/>
          </a:xfrm>
          <a:prstGeom prst="rect">
            <a:avLst/>
          </a:prstGeom>
          <a:ln w="0">
            <a:noFill/>
          </a:ln>
        </p:spPr>
      </p:pic>
      <p:pic>
        <p:nvPicPr>
          <p:cNvPr id="43" name="" descr=""/>
          <p:cNvPicPr/>
          <p:nvPr/>
        </p:nvPicPr>
        <p:blipFill>
          <a:blip r:embed="rId3"/>
          <a:stretch/>
        </p:blipFill>
        <p:spPr>
          <a:xfrm>
            <a:off x="3781440" y="5442120"/>
            <a:ext cx="299880" cy="357120"/>
          </a:xfrm>
          <a:prstGeom prst="rect">
            <a:avLst/>
          </a:prstGeom>
          <a:ln w="0">
            <a:noFill/>
          </a:ln>
        </p:spPr>
      </p:pic>
      <p:pic>
        <p:nvPicPr>
          <p:cNvPr id="44" name="" descr=""/>
          <p:cNvPicPr/>
          <p:nvPr/>
        </p:nvPicPr>
        <p:blipFill>
          <a:blip r:embed="rId4"/>
          <a:stretch/>
        </p:blipFill>
        <p:spPr>
          <a:xfrm>
            <a:off x="4189320" y="6323040"/>
            <a:ext cx="128520" cy="471600"/>
          </a:xfrm>
          <a:prstGeom prst="rect">
            <a:avLst/>
          </a:prstGeom>
          <a:ln w="0">
            <a:noFill/>
          </a:ln>
        </p:spPr>
      </p:pic>
      <p:pic>
        <p:nvPicPr>
          <p:cNvPr id="45" name="" descr=""/>
          <p:cNvPicPr/>
          <p:nvPr/>
        </p:nvPicPr>
        <p:blipFill>
          <a:blip r:embed="rId5"/>
          <a:stretch/>
        </p:blipFill>
        <p:spPr>
          <a:xfrm>
            <a:off x="3314880" y="6095880"/>
            <a:ext cx="253800" cy="789120"/>
          </a:xfrm>
          <a:prstGeom prst="rect">
            <a:avLst/>
          </a:prstGeom>
          <a:ln w="0">
            <a:noFill/>
          </a:ln>
        </p:spPr>
      </p:pic>
      <p:pic>
        <p:nvPicPr>
          <p:cNvPr id="46" name="" descr=""/>
          <p:cNvPicPr/>
          <p:nvPr/>
        </p:nvPicPr>
        <p:blipFill>
          <a:blip r:embed="rId6"/>
          <a:stretch/>
        </p:blipFill>
        <p:spPr>
          <a:xfrm>
            <a:off x="4113360" y="7327800"/>
            <a:ext cx="365040" cy="328680"/>
          </a:xfrm>
          <a:prstGeom prst="rect">
            <a:avLst/>
          </a:prstGeom>
          <a:ln w="0">
            <a:noFill/>
          </a:ln>
        </p:spPr>
      </p:pic>
      <p:sp>
        <p:nvSpPr>
          <p:cNvPr id="47" name=""/>
          <p:cNvSpPr/>
          <p:nvPr/>
        </p:nvSpPr>
        <p:spPr>
          <a:xfrm rot="19476000">
            <a:off x="1723680" y="3612960"/>
            <a:ext cx="76320" cy="38088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8" name=""/>
          <p:cNvSpPr/>
          <p:nvPr/>
        </p:nvSpPr>
        <p:spPr>
          <a:xfrm>
            <a:off x="1816920" y="3897000"/>
            <a:ext cx="200160" cy="2563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9" name=""/>
          <p:cNvSpPr/>
          <p:nvPr/>
        </p:nvSpPr>
        <p:spPr>
          <a:xfrm rot="19529400">
            <a:off x="1571760" y="3612960"/>
            <a:ext cx="152280" cy="7596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160" bIns="2916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50" name=""/>
          <p:cNvGrpSpPr/>
          <p:nvPr/>
        </p:nvGrpSpPr>
        <p:grpSpPr>
          <a:xfrm>
            <a:off x="228600" y="2743200"/>
            <a:ext cx="685800" cy="152280"/>
            <a:chOff x="228600" y="2743200"/>
            <a:chExt cx="685800" cy="152280"/>
          </a:xfrm>
        </p:grpSpPr>
        <p:sp>
          <p:nvSpPr>
            <p:cNvPr id="51" name=""/>
            <p:cNvSpPr/>
            <p:nvPr/>
          </p:nvSpPr>
          <p:spPr>
            <a:xfrm>
              <a:off x="228600" y="2743200"/>
              <a:ext cx="685800" cy="1522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228600" y="2793600"/>
              <a:ext cx="685800" cy="101520"/>
            </a:xfrm>
            <a:prstGeom prst="rect">
              <a:avLst/>
            </a:prstGeom>
            <a:solidFill>
              <a:srgbClr val="fb261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53" name=""/>
          <p:cNvSpPr/>
          <p:nvPr/>
        </p:nvSpPr>
        <p:spPr>
          <a:xfrm flipV="1">
            <a:off x="1752480" y="1523880"/>
            <a:ext cx="1600200" cy="208944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4" name=""/>
          <p:cNvSpPr/>
          <p:nvPr/>
        </p:nvSpPr>
        <p:spPr>
          <a:xfrm>
            <a:off x="2790720" y="4222800"/>
            <a:ext cx="45720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5" name=""/>
          <p:cNvSpPr/>
          <p:nvPr/>
        </p:nvSpPr>
        <p:spPr>
          <a:xfrm>
            <a:off x="3962520" y="4451400"/>
            <a:ext cx="0" cy="9144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6" name=""/>
          <p:cNvSpPr/>
          <p:nvPr/>
        </p:nvSpPr>
        <p:spPr>
          <a:xfrm flipH="1">
            <a:off x="3628800" y="5805360"/>
            <a:ext cx="228600" cy="2286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7" name=""/>
          <p:cNvSpPr/>
          <p:nvPr/>
        </p:nvSpPr>
        <p:spPr>
          <a:xfrm>
            <a:off x="4010040" y="5805360"/>
            <a:ext cx="152280" cy="2286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8" name=""/>
          <p:cNvSpPr/>
          <p:nvPr/>
        </p:nvSpPr>
        <p:spPr>
          <a:xfrm>
            <a:off x="4265640" y="6870600"/>
            <a:ext cx="0" cy="30492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9" name=""/>
          <p:cNvSpPr/>
          <p:nvPr/>
        </p:nvSpPr>
        <p:spPr>
          <a:xfrm>
            <a:off x="3416400" y="6885000"/>
            <a:ext cx="0" cy="30492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60" name=""/>
          <p:cNvGrpSpPr/>
          <p:nvPr/>
        </p:nvGrpSpPr>
        <p:grpSpPr>
          <a:xfrm>
            <a:off x="228600" y="1447920"/>
            <a:ext cx="685800" cy="152280"/>
            <a:chOff x="228600" y="1447920"/>
            <a:chExt cx="685800" cy="152280"/>
          </a:xfrm>
        </p:grpSpPr>
        <p:sp>
          <p:nvSpPr>
            <p:cNvPr id="61" name=""/>
            <p:cNvSpPr/>
            <p:nvPr/>
          </p:nvSpPr>
          <p:spPr>
            <a:xfrm>
              <a:off x="228600" y="1447920"/>
              <a:ext cx="685800" cy="1522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228600" y="1498320"/>
              <a:ext cx="685800" cy="101520"/>
            </a:xfrm>
            <a:prstGeom prst="rect">
              <a:avLst/>
            </a:prstGeom>
            <a:solidFill>
              <a:srgbClr val="fb261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63" name=""/>
          <p:cNvSpPr/>
          <p:nvPr/>
        </p:nvSpPr>
        <p:spPr>
          <a:xfrm>
            <a:off x="468360" y="2362320"/>
            <a:ext cx="0" cy="38088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4" name=""/>
          <p:cNvSpPr/>
          <p:nvPr/>
        </p:nvSpPr>
        <p:spPr>
          <a:xfrm>
            <a:off x="838080" y="1371600"/>
            <a:ext cx="762120" cy="385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+LIF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+G418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5" name=""/>
          <p:cNvSpPr/>
          <p:nvPr/>
        </p:nvSpPr>
        <p:spPr>
          <a:xfrm>
            <a:off x="76320" y="1761120"/>
            <a:ext cx="1828800" cy="677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spAutoFit/>
          </a:bodyPr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One passage before being harvested for injections, 47-1 ES cells grown without G418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6" name=""/>
          <p:cNvSpPr/>
          <p:nvPr/>
        </p:nvSpPr>
        <p:spPr>
          <a:xfrm>
            <a:off x="152280" y="152280"/>
            <a:ext cx="2225880" cy="126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D3 and 47-1 ES cells grown on mitotically inactivated feeders, and in medium containing LIF to maintain non-differentiation and pluripotency. 47-1 cells also grown in G418 to select for HSA21-containing cells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7" name=""/>
          <p:cNvSpPr/>
          <p:nvPr/>
        </p:nvSpPr>
        <p:spPr>
          <a:xfrm>
            <a:off x="914400" y="4451400"/>
            <a:ext cx="2209680" cy="11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Thirty syngeneic 129/Sv male mice injected each with equal numbers of D3 and 47-1 ES cells in their right and left flanks respectively, in 3 independent experiments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8" name=""/>
          <p:cNvSpPr/>
          <p:nvPr/>
        </p:nvSpPr>
        <p:spPr>
          <a:xfrm>
            <a:off x="4632480" y="3730680"/>
            <a:ext cx="169200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Mice sacrificed and tumours removed 30 days post ES cell injection.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9" name=""/>
          <p:cNvSpPr/>
          <p:nvPr/>
        </p:nvSpPr>
        <p:spPr>
          <a:xfrm>
            <a:off x="4251240" y="5060880"/>
            <a:ext cx="1844640" cy="11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Each tumour is cut in half. One half is fixed in 10% buffered formalin and paraffin-embedded. The other half is snap-frozen in liquid nitrogen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0" name=""/>
          <p:cNvSpPr/>
          <p:nvPr/>
        </p:nvSpPr>
        <p:spPr>
          <a:xfrm>
            <a:off x="4632480" y="7010280"/>
            <a:ext cx="2149200" cy="100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DNA and RNA extracted from frozen tumours and used in PCR and RT-PCR analyses of HSA21 retention in 47-1 tumours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1" name=""/>
          <p:cNvSpPr/>
          <p:nvPr/>
        </p:nvSpPr>
        <p:spPr>
          <a:xfrm>
            <a:off x="990720" y="6934320"/>
            <a:ext cx="2286000" cy="100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araffin sections of tumours subjected to a blinded H&amp;E analysis and immunofluorescent staining with neural-specific markers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2" name=""/>
          <p:cNvSpPr/>
          <p:nvPr/>
        </p:nvSpPr>
        <p:spPr>
          <a:xfrm>
            <a:off x="3838320" y="7650000"/>
            <a:ext cx="881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DNA/RNA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3" name=""/>
          <p:cNvSpPr/>
          <p:nvPr/>
        </p:nvSpPr>
        <p:spPr>
          <a:xfrm>
            <a:off x="380880" y="8458200"/>
            <a:ext cx="6019920" cy="1284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Supplementary info 1 – Procedure for generating wildtype and transchromosomic teratomas and the subsequent analysis of these tumours.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 algn="just"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The transchromosomic ES cell line used, 47-1, is one of a panel of 21 transchromosomic ES cells generated by Hernandez et al (1999). The 47-1 cell line contains an entire, single, freely segregating HSA21 on the background of a normal mouse genome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4" name=""/>
          <p:cNvSpPr/>
          <p:nvPr/>
        </p:nvSpPr>
        <p:spPr>
          <a:xfrm>
            <a:off x="914400" y="3048120"/>
            <a:ext cx="609480" cy="4572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5" name=""/>
          <p:cNvSpPr/>
          <p:nvPr/>
        </p:nvSpPr>
        <p:spPr>
          <a:xfrm>
            <a:off x="2438280" y="380880"/>
            <a:ext cx="2057400" cy="1006560"/>
          </a:xfrm>
          <a:prstGeom prst="rect">
            <a:avLst/>
          </a:prstGeom>
          <a:noFill/>
          <a:ln w="2844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ISH analysis with HSA21-specific centromeric DNA probe to confirm presence of HSA21 in 47-1 ES cells (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upplementary figure 2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)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6" name=""/>
          <p:cNvSpPr/>
          <p:nvPr/>
        </p:nvSpPr>
        <p:spPr>
          <a:xfrm flipV="1">
            <a:off x="1981080" y="2514600"/>
            <a:ext cx="2590920" cy="129528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7" name=""/>
          <p:cNvSpPr/>
          <p:nvPr/>
        </p:nvSpPr>
        <p:spPr>
          <a:xfrm>
            <a:off x="4572000" y="1709640"/>
            <a:ext cx="2209680" cy="824040"/>
          </a:xfrm>
          <a:prstGeom prst="rect">
            <a:avLst/>
          </a:prstGeom>
          <a:noFill/>
          <a:ln w="2844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CR and RT-PCR analysis with 41 HSA21-specific markers; 33 gDNA, and 8 cDNA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8" name=""/>
          <p:cNvSpPr/>
          <p:nvPr/>
        </p:nvSpPr>
        <p:spPr>
          <a:xfrm>
            <a:off x="2286000" y="2590920"/>
            <a:ext cx="1828800" cy="459000"/>
          </a:xfrm>
          <a:prstGeom prst="rect">
            <a:avLst/>
          </a:prstGeom>
          <a:solidFill>
            <a:srgbClr val="ff0000"/>
          </a:solidFill>
          <a:ln w="2844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ES cells before injection checked for: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9" name=""/>
          <p:cNvSpPr/>
          <p:nvPr/>
        </p:nvSpPr>
        <p:spPr>
          <a:xfrm>
            <a:off x="838080" y="2664000"/>
            <a:ext cx="762120" cy="385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+LIF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G418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0" name=""/>
          <p:cNvSpPr/>
          <p:nvPr/>
        </p:nvSpPr>
        <p:spPr>
          <a:xfrm flipV="1">
            <a:off x="6248520" y="2742840"/>
            <a:ext cx="0" cy="426708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81" name="" descr=""/>
          <p:cNvPicPr/>
          <p:nvPr/>
        </p:nvPicPr>
        <p:blipFill>
          <a:blip r:embed="rId7"/>
          <a:stretch/>
        </p:blipFill>
        <p:spPr>
          <a:xfrm>
            <a:off x="3068640" y="7184880"/>
            <a:ext cx="685800" cy="6843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4-11-29T11:42:33Z</dcterms:created>
  <dc:creator>Afua Mensah</dc:creator>
  <dc:description/>
  <dc:language>en-US</dc:language>
  <cp:lastModifiedBy>Professor Dean Nizetic</cp:lastModifiedBy>
  <dcterms:modified xsi:type="dcterms:W3CDTF">2007-05-02T11:25:16Z</dcterms:modified>
  <cp:revision>13</cp:revision>
  <dc:subject/>
  <dc:title>PowerPoint Presentation</dc:title>
</cp:coreProperties>
</file>